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3" r:id="rId2"/>
  </p:sldIdLst>
  <p:sldSz cx="12192000" cy="6858000"/>
  <p:notesSz cx="6888163" cy="1001871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113" d="100"/>
          <a:sy n="113" d="100"/>
        </p:scale>
        <p:origin x="432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5"/>
    </mc:Choice>
    <mc:Fallback>
      <c:style val="5"/>
    </mc:Fallback>
  </mc:AlternateContent>
  <c:chart>
    <c:autoTitleDeleted val="1"/>
    <c:plotArea>
      <c:layout/>
      <c:barChart>
        <c:barDir val="bar"/>
        <c:grouping val="clustered"/>
        <c:varyColors val="0"/>
        <c:ser>
          <c:idx val="0"/>
          <c:order val="0"/>
          <c:tx>
            <c:strRef>
              <c:f>Foglio1!$E$2:$E$3</c:f>
              <c:strCache>
                <c:ptCount val="2"/>
                <c:pt idx="1">
                  <c:v>&lt;8 years </c:v>
                </c:pt>
              </c:strCache>
            </c:strRef>
          </c:tx>
          <c:spPr>
            <a:gradFill rotWithShape="1">
              <a:gsLst>
                <a:gs pos="0">
                  <a:schemeClr val="accent3">
                    <a:tint val="65000"/>
                    <a:satMod val="103000"/>
                    <a:lumMod val="102000"/>
                    <a:tint val="94000"/>
                  </a:schemeClr>
                </a:gs>
                <a:gs pos="50000">
                  <a:schemeClr val="accent3">
                    <a:tint val="65000"/>
                    <a:satMod val="110000"/>
                    <a:lumMod val="100000"/>
                    <a:shade val="100000"/>
                  </a:schemeClr>
                </a:gs>
                <a:gs pos="100000">
                  <a:schemeClr val="accent3">
                    <a:tint val="65000"/>
                    <a:lumMod val="99000"/>
                    <a:satMod val="120000"/>
                    <a:shade val="78000"/>
                  </a:schemeClr>
                </a:gs>
              </a:gsLst>
              <a:lin ang="5400000" scaled="0"/>
            </a:gra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197" b="0" i="0" u="none" strike="noStrike" kern="1200" baseline="0">
                    <a:solidFill>
                      <a:schemeClr val="tx2"/>
                    </a:solidFill>
                    <a:latin typeface="+mn-lt"/>
                    <a:ea typeface="+mn-ea"/>
                    <a:cs typeface="+mn-cs"/>
                  </a:defRPr>
                </a:pPr>
                <a:endParaRPr lang="it-IT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>
                      <a:solidFill>
                        <a:schemeClr val="tx2">
                          <a:lumMod val="35000"/>
                          <a:lumOff val="65000"/>
                        </a:schemeClr>
                      </a:solidFill>
                    </a:ln>
                    <a:effectLst/>
                  </c:spPr>
                </c15:leaderLines>
              </c:ext>
            </c:extLst>
          </c:dLbls>
          <c:cat>
            <c:multiLvlStrRef>
              <c:f>Foglio1!$C$4:$D$15</c:f>
              <c:multiLvlStrCache>
                <c:ptCount val="12"/>
                <c:lvl>
                  <c:pt idx="0">
                    <c:v>No problems</c:v>
                  </c:pt>
                  <c:pt idx="1">
                    <c:v>Any problems ⸙</c:v>
                  </c:pt>
                  <c:pt idx="2">
                    <c:v>No problems</c:v>
                  </c:pt>
                  <c:pt idx="3">
                    <c:v>Any problems </c:v>
                  </c:pt>
                  <c:pt idx="4">
                    <c:v>No problems</c:v>
                  </c:pt>
                  <c:pt idx="5">
                    <c:v>Any problems </c:v>
                  </c:pt>
                  <c:pt idx="6">
                    <c:v>No problems</c:v>
                  </c:pt>
                  <c:pt idx="7">
                    <c:v>Any problems</c:v>
                  </c:pt>
                  <c:pt idx="8">
                    <c:v>No problems</c:v>
                  </c:pt>
                  <c:pt idx="9">
                    <c:v>Any problems</c:v>
                  </c:pt>
                  <c:pt idx="10">
                    <c:v>No problems</c:v>
                  </c:pt>
                  <c:pt idx="11">
                    <c:v>Any problems</c:v>
                  </c:pt>
                </c:lvl>
                <c:lvl>
                  <c:pt idx="0">
                    <c:v>Mobility</c:v>
                  </c:pt>
                  <c:pt idx="2">
                    <c:v>Self-Care</c:v>
                  </c:pt>
                  <c:pt idx="4">
                    <c:v>Usual Activities</c:v>
                  </c:pt>
                  <c:pt idx="6">
                    <c:v>Pain/ Discomfort</c:v>
                  </c:pt>
                  <c:pt idx="8">
                    <c:v>Anxiety/ Depression</c:v>
                  </c:pt>
                  <c:pt idx="10">
                    <c:v>Any Dimension</c:v>
                  </c:pt>
                </c:lvl>
              </c:multiLvlStrCache>
            </c:multiLvlStrRef>
          </c:cat>
          <c:val>
            <c:numRef>
              <c:f>Foglio1!$E$4:$E$15</c:f>
              <c:numCache>
                <c:formatCode>0.0%</c:formatCode>
                <c:ptCount val="12"/>
                <c:pt idx="0">
                  <c:v>0.86199999999999999</c:v>
                </c:pt>
                <c:pt idx="1">
                  <c:v>0.13800000000000001</c:v>
                </c:pt>
                <c:pt idx="2">
                  <c:v>1</c:v>
                </c:pt>
                <c:pt idx="3">
                  <c:v>0</c:v>
                </c:pt>
                <c:pt idx="4">
                  <c:v>0.93100000000000005</c:v>
                </c:pt>
                <c:pt idx="5">
                  <c:v>6.9000000000000006E-2</c:v>
                </c:pt>
                <c:pt idx="6">
                  <c:v>0.75900000000000001</c:v>
                </c:pt>
                <c:pt idx="7">
                  <c:v>0.24099999999999999</c:v>
                </c:pt>
                <c:pt idx="8">
                  <c:v>0.96599999999999997</c:v>
                </c:pt>
                <c:pt idx="9">
                  <c:v>3.4000000000000002E-2</c:v>
                </c:pt>
                <c:pt idx="10">
                  <c:v>0.65500000000000003</c:v>
                </c:pt>
                <c:pt idx="11">
                  <c:v>0.3449999999999999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AA7-4601-B5C7-5400D3B409D2}"/>
            </c:ext>
          </c:extLst>
        </c:ser>
        <c:ser>
          <c:idx val="1"/>
          <c:order val="1"/>
          <c:tx>
            <c:strRef>
              <c:f>Foglio1!$F$2:$F$3</c:f>
              <c:strCache>
                <c:ptCount val="2"/>
                <c:pt idx="1">
                  <c:v>8-15 years </c:v>
                </c:pt>
              </c:strCache>
            </c:strRef>
          </c:tx>
          <c:spPr>
            <a:gradFill rotWithShape="1">
              <a:gsLst>
                <a:gs pos="0">
                  <a:schemeClr val="accent3">
                    <a:satMod val="103000"/>
                    <a:lumMod val="102000"/>
                    <a:tint val="94000"/>
                  </a:schemeClr>
                </a:gs>
                <a:gs pos="50000">
                  <a:schemeClr val="accent3">
                    <a:satMod val="110000"/>
                    <a:lumMod val="100000"/>
                    <a:shade val="100000"/>
                  </a:schemeClr>
                </a:gs>
                <a:gs pos="100000">
                  <a:schemeClr val="accent3">
                    <a:lumMod val="99000"/>
                    <a:satMod val="120000"/>
                    <a:shade val="78000"/>
                  </a:schemeClr>
                </a:gs>
              </a:gsLst>
              <a:lin ang="5400000" scaled="0"/>
            </a:gra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197" b="0" i="0" u="none" strike="noStrike" kern="1200" baseline="0">
                    <a:solidFill>
                      <a:schemeClr val="tx2"/>
                    </a:solidFill>
                    <a:latin typeface="+mn-lt"/>
                    <a:ea typeface="+mn-ea"/>
                    <a:cs typeface="+mn-cs"/>
                  </a:defRPr>
                </a:pPr>
                <a:endParaRPr lang="it-IT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>
                      <a:solidFill>
                        <a:schemeClr val="tx2">
                          <a:lumMod val="35000"/>
                          <a:lumOff val="65000"/>
                        </a:schemeClr>
                      </a:solidFill>
                    </a:ln>
                    <a:effectLst/>
                  </c:spPr>
                </c15:leaderLines>
              </c:ext>
            </c:extLst>
          </c:dLbls>
          <c:cat>
            <c:multiLvlStrRef>
              <c:f>Foglio1!$C$4:$D$15</c:f>
              <c:multiLvlStrCache>
                <c:ptCount val="12"/>
                <c:lvl>
                  <c:pt idx="0">
                    <c:v>No problems</c:v>
                  </c:pt>
                  <c:pt idx="1">
                    <c:v>Any problems ⸙</c:v>
                  </c:pt>
                  <c:pt idx="2">
                    <c:v>No problems</c:v>
                  </c:pt>
                  <c:pt idx="3">
                    <c:v>Any problems </c:v>
                  </c:pt>
                  <c:pt idx="4">
                    <c:v>No problems</c:v>
                  </c:pt>
                  <c:pt idx="5">
                    <c:v>Any problems </c:v>
                  </c:pt>
                  <c:pt idx="6">
                    <c:v>No problems</c:v>
                  </c:pt>
                  <c:pt idx="7">
                    <c:v>Any problems</c:v>
                  </c:pt>
                  <c:pt idx="8">
                    <c:v>No problems</c:v>
                  </c:pt>
                  <c:pt idx="9">
                    <c:v>Any problems</c:v>
                  </c:pt>
                  <c:pt idx="10">
                    <c:v>No problems</c:v>
                  </c:pt>
                  <c:pt idx="11">
                    <c:v>Any problems</c:v>
                  </c:pt>
                </c:lvl>
                <c:lvl>
                  <c:pt idx="0">
                    <c:v>Mobility</c:v>
                  </c:pt>
                  <c:pt idx="2">
                    <c:v>Self-Care</c:v>
                  </c:pt>
                  <c:pt idx="4">
                    <c:v>Usual Activities</c:v>
                  </c:pt>
                  <c:pt idx="6">
                    <c:v>Pain/ Discomfort</c:v>
                  </c:pt>
                  <c:pt idx="8">
                    <c:v>Anxiety/ Depression</c:v>
                  </c:pt>
                  <c:pt idx="10">
                    <c:v>Any Dimension</c:v>
                  </c:pt>
                </c:lvl>
              </c:multiLvlStrCache>
            </c:multiLvlStrRef>
          </c:cat>
          <c:val>
            <c:numRef>
              <c:f>Foglio1!$F$4:$F$15</c:f>
              <c:numCache>
                <c:formatCode>0.0%</c:formatCode>
                <c:ptCount val="12"/>
                <c:pt idx="0">
                  <c:v>0.86799999999999999</c:v>
                </c:pt>
                <c:pt idx="1">
                  <c:v>0.13200000000000001</c:v>
                </c:pt>
                <c:pt idx="2">
                  <c:v>0.94099999999999995</c:v>
                </c:pt>
                <c:pt idx="3">
                  <c:v>5.8999999999999997E-2</c:v>
                </c:pt>
                <c:pt idx="4">
                  <c:v>0.82399999999999995</c:v>
                </c:pt>
                <c:pt idx="5">
                  <c:v>0.17599999999999999</c:v>
                </c:pt>
                <c:pt idx="6">
                  <c:v>0.52900000000000003</c:v>
                </c:pt>
                <c:pt idx="7">
                  <c:v>0.47099999999999997</c:v>
                </c:pt>
                <c:pt idx="8">
                  <c:v>0.67600000000000005</c:v>
                </c:pt>
                <c:pt idx="9">
                  <c:v>0.32400000000000001</c:v>
                </c:pt>
                <c:pt idx="10">
                  <c:v>0.38200000000000001</c:v>
                </c:pt>
                <c:pt idx="11">
                  <c:v>0.617999999999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2AA7-4601-B5C7-5400D3B409D2}"/>
            </c:ext>
          </c:extLst>
        </c:ser>
        <c:ser>
          <c:idx val="2"/>
          <c:order val="2"/>
          <c:tx>
            <c:strRef>
              <c:f>Foglio1!$G$2:$G$3</c:f>
              <c:strCache>
                <c:ptCount val="2"/>
                <c:pt idx="1">
                  <c:v>≥16 years </c:v>
                </c:pt>
              </c:strCache>
            </c:strRef>
          </c:tx>
          <c:spPr>
            <a:gradFill rotWithShape="1">
              <a:gsLst>
                <a:gs pos="0">
                  <a:schemeClr val="accent3">
                    <a:shade val="65000"/>
                    <a:satMod val="103000"/>
                    <a:lumMod val="102000"/>
                    <a:tint val="94000"/>
                  </a:schemeClr>
                </a:gs>
                <a:gs pos="50000">
                  <a:schemeClr val="accent3">
                    <a:shade val="65000"/>
                    <a:satMod val="110000"/>
                    <a:lumMod val="100000"/>
                    <a:shade val="100000"/>
                  </a:schemeClr>
                </a:gs>
                <a:gs pos="100000">
                  <a:schemeClr val="accent3">
                    <a:shade val="65000"/>
                    <a:lumMod val="99000"/>
                    <a:satMod val="120000"/>
                    <a:shade val="78000"/>
                  </a:schemeClr>
                </a:gs>
              </a:gsLst>
              <a:lin ang="5400000" scaled="0"/>
            </a:gra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197" b="0" i="0" u="none" strike="noStrike" kern="1200" baseline="0">
                    <a:solidFill>
                      <a:schemeClr val="tx2"/>
                    </a:solidFill>
                    <a:latin typeface="+mn-lt"/>
                    <a:ea typeface="+mn-ea"/>
                    <a:cs typeface="+mn-cs"/>
                  </a:defRPr>
                </a:pPr>
                <a:endParaRPr lang="it-IT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>
                      <a:solidFill>
                        <a:schemeClr val="tx2">
                          <a:lumMod val="35000"/>
                          <a:lumOff val="65000"/>
                        </a:schemeClr>
                      </a:solidFill>
                    </a:ln>
                    <a:effectLst/>
                  </c:spPr>
                </c15:leaderLines>
              </c:ext>
            </c:extLst>
          </c:dLbls>
          <c:cat>
            <c:multiLvlStrRef>
              <c:f>Foglio1!$C$4:$D$15</c:f>
              <c:multiLvlStrCache>
                <c:ptCount val="12"/>
                <c:lvl>
                  <c:pt idx="0">
                    <c:v>No problems</c:v>
                  </c:pt>
                  <c:pt idx="1">
                    <c:v>Any problems ⸙</c:v>
                  </c:pt>
                  <c:pt idx="2">
                    <c:v>No problems</c:v>
                  </c:pt>
                  <c:pt idx="3">
                    <c:v>Any problems </c:v>
                  </c:pt>
                  <c:pt idx="4">
                    <c:v>No problems</c:v>
                  </c:pt>
                  <c:pt idx="5">
                    <c:v>Any problems </c:v>
                  </c:pt>
                  <c:pt idx="6">
                    <c:v>No problems</c:v>
                  </c:pt>
                  <c:pt idx="7">
                    <c:v>Any problems</c:v>
                  </c:pt>
                  <c:pt idx="8">
                    <c:v>No problems</c:v>
                  </c:pt>
                  <c:pt idx="9">
                    <c:v>Any problems</c:v>
                  </c:pt>
                  <c:pt idx="10">
                    <c:v>No problems</c:v>
                  </c:pt>
                  <c:pt idx="11">
                    <c:v>Any problems</c:v>
                  </c:pt>
                </c:lvl>
                <c:lvl>
                  <c:pt idx="0">
                    <c:v>Mobility</c:v>
                  </c:pt>
                  <c:pt idx="2">
                    <c:v>Self-Care</c:v>
                  </c:pt>
                  <c:pt idx="4">
                    <c:v>Usual Activities</c:v>
                  </c:pt>
                  <c:pt idx="6">
                    <c:v>Pain/ Discomfort</c:v>
                  </c:pt>
                  <c:pt idx="8">
                    <c:v>Anxiety/ Depression</c:v>
                  </c:pt>
                  <c:pt idx="10">
                    <c:v>Any Dimension</c:v>
                  </c:pt>
                </c:lvl>
              </c:multiLvlStrCache>
            </c:multiLvlStrRef>
          </c:cat>
          <c:val>
            <c:numRef>
              <c:f>Foglio1!$G$4:$G$15</c:f>
              <c:numCache>
                <c:formatCode>0.0%</c:formatCode>
                <c:ptCount val="12"/>
                <c:pt idx="0">
                  <c:v>0.51600000000000001</c:v>
                </c:pt>
                <c:pt idx="1">
                  <c:v>0.48399999999999999</c:v>
                </c:pt>
                <c:pt idx="2">
                  <c:v>0.67700000000000005</c:v>
                </c:pt>
                <c:pt idx="3">
                  <c:v>0.32300000000000001</c:v>
                </c:pt>
                <c:pt idx="4">
                  <c:v>0.45200000000000001</c:v>
                </c:pt>
                <c:pt idx="5">
                  <c:v>0.54800000000000004</c:v>
                </c:pt>
                <c:pt idx="6">
                  <c:v>0.22600000000000001</c:v>
                </c:pt>
                <c:pt idx="7">
                  <c:v>0.77400000000000002</c:v>
                </c:pt>
                <c:pt idx="8">
                  <c:v>0.45200000000000001</c:v>
                </c:pt>
                <c:pt idx="9">
                  <c:v>0.54800000000000004</c:v>
                </c:pt>
                <c:pt idx="10">
                  <c:v>9.7000000000000003E-2</c:v>
                </c:pt>
                <c:pt idx="11">
                  <c:v>0.903000000000000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2AA7-4601-B5C7-5400D3B409D2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100"/>
        <c:axId val="229449712"/>
        <c:axId val="53148720"/>
      </c:barChart>
      <c:catAx>
        <c:axId val="229449712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2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2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it-IT"/>
          </a:p>
        </c:txPr>
        <c:crossAx val="53148720"/>
        <c:crosses val="autoZero"/>
        <c:auto val="1"/>
        <c:lblAlgn val="ctr"/>
        <c:lblOffset val="100"/>
        <c:noMultiLvlLbl val="0"/>
      </c:catAx>
      <c:valAx>
        <c:axId val="53148720"/>
        <c:scaling>
          <c:orientation val="minMax"/>
          <c:max val="1"/>
        </c:scaling>
        <c:delete val="0"/>
        <c:axPos val="b"/>
        <c:majorGridlines>
          <c:spPr>
            <a:ln w="9525" cap="flat" cmpd="sng" algn="ctr">
              <a:solidFill>
                <a:schemeClr val="tx2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2"/>
                </a:solidFill>
                <a:latin typeface="+mn-lt"/>
                <a:ea typeface="+mn-ea"/>
                <a:cs typeface="+mn-cs"/>
              </a:defRPr>
            </a:pPr>
            <a:endParaRPr lang="it-IT"/>
          </a:p>
        </c:txPr>
        <c:crossAx val="22944971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chemeClr val="tx2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it-IT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it-IT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withinLinearReversed" id="23">
  <a:schemeClr val="accent3"/>
</cs:colorStyle>
</file>

<file path=ppt/charts/style1.xml><?xml version="1.0" encoding="utf-8"?>
<cs:chartStyle xmlns:cs="http://schemas.microsoft.com/office/drawing/2012/chartStyle" xmlns:a="http://schemas.openxmlformats.org/drawingml/2006/main" id="220">
  <cs:axisTitle>
    <cs:lnRef idx="0"/>
    <cs:fillRef idx="0"/>
    <cs:effectRef idx="0"/>
    <cs:fontRef idx="minor">
      <a:schemeClr val="tx2"/>
    </cs:fontRef>
    <cs:defRPr sz="1197" b="1" kern="1200"/>
  </cs:axisTitle>
  <cs:categoryAxis>
    <cs:lnRef idx="0"/>
    <cs:fillRef idx="0"/>
    <cs:effectRef idx="0"/>
    <cs:fontRef idx="minor">
      <a:schemeClr val="tx2"/>
    </cs:fontRef>
    <cs:spPr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2"/>
    </cs:fontRef>
    <cs:spPr>
      <a:solidFill>
        <a:schemeClr val="bg1"/>
      </a:solidFill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2"/>
    </cs:fontRef>
    <cs:defRPr sz="1197" kern="1200"/>
  </cs:dataLabel>
  <cs:dataLabelCallout>
    <cs:lnRef idx="0"/>
    <cs:fillRef idx="0"/>
    <cs:effectRef idx="0"/>
    <cs:fontRef idx="minor">
      <a:schemeClr val="dk2">
        <a:lumMod val="7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3">
      <cs:styleClr val="auto"/>
    </cs:fillRef>
    <cs:effectRef idx="2"/>
    <cs:fontRef idx="minor">
      <a:schemeClr val="tx2"/>
    </cs:fontRef>
  </cs:dataPoint>
  <cs:dataPoint3D>
    <cs:lnRef idx="0"/>
    <cs:fillRef idx="3">
      <cs:styleClr val="auto"/>
    </cs:fillRef>
    <cs:effectRef idx="2"/>
    <cs:fontRef idx="minor">
      <a:schemeClr val="tx2"/>
    </cs:fontRef>
  </cs:dataPoint3D>
  <cs:dataPointLine>
    <cs:lnRef idx="0">
      <cs:styleClr val="auto"/>
    </cs:lnRef>
    <cs:fillRef idx="3"/>
    <cs:effectRef idx="2"/>
    <cs:fontRef idx="minor">
      <a:schemeClr val="tx2"/>
    </cs:fontRef>
    <cs:spPr>
      <a:ln w="31750" cap="rnd">
        <a:solidFill>
          <a:schemeClr val="phClr"/>
        </a:solidFill>
        <a:round/>
      </a:ln>
    </cs:spPr>
  </cs:dataPointLine>
  <cs:dataPointMarker>
    <cs:lnRef idx="0"/>
    <cs:fillRef idx="3">
      <cs:styleClr val="auto"/>
    </cs:fillRef>
    <cs:effectRef idx="2"/>
    <cs:fontRef idx="minor">
      <a:schemeClr val="tx2"/>
    </cs:fontRef>
    <cs:spPr>
      <a:ln w="12700">
        <a:solidFill>
          <a:schemeClr val="lt2"/>
        </a:solidFill>
        <a:round/>
      </a:ln>
    </cs:spPr>
  </cs:dataPointMarker>
  <cs:dataPointMarkerLayout symbol="circle" size="6"/>
  <cs:dataPointWireframe>
    <cs:lnRef idx="0">
      <cs:styleClr val="auto"/>
    </cs:lnRef>
    <cs:fillRef idx="3"/>
    <cs:effectRef idx="2"/>
    <cs:fontRef idx="minor">
      <a:schemeClr val="tx2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2"/>
    </cs:fontRef>
    <cs:spPr>
      <a:ln w="9525">
        <a:solidFill>
          <a:schemeClr val="tx2">
            <a:lumMod val="15000"/>
            <a:lumOff val="85000"/>
          </a:schemeClr>
        </a:solidFill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60000"/>
            <a:lumOff val="40000"/>
          </a:schemeClr>
        </a:solidFill>
        <a:prstDash val="dash"/>
      </a:ln>
    </cs:spPr>
  </cs:dropLine>
  <cs:errorBar>
    <cs:lnRef idx="0"/>
    <cs:fillRef idx="0"/>
    <cs:effectRef idx="0"/>
    <cs:fontRef idx="minor">
      <a:schemeClr val="tx2"/>
    </cs:fontRef>
    <cs:spPr>
      <a:ln w="9525">
        <a:solidFill>
          <a:schemeClr val="tx2">
            <a:lumMod val="75000"/>
          </a:schemeClr>
        </a:solidFill>
        <a:round/>
      </a:ln>
    </cs:spPr>
  </cs:errorBar>
  <cs:floor>
    <cs:lnRef idx="0"/>
    <cs:fillRef idx="0"/>
    <cs:effectRef idx="0"/>
    <cs:fontRef idx="minor">
      <a:schemeClr val="tx2"/>
    </cs:fontRef>
  </cs:floor>
  <cs:gridlineMajor>
    <cs:lnRef idx="0"/>
    <cs:fillRef idx="0"/>
    <cs:effectRef idx="0"/>
    <cs:fontRef idx="minor">
      <a:schemeClr val="tx2"/>
    </cs:fontRef>
    <cs:spPr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2"/>
    </cs:fontRef>
    <cs:spPr>
      <a:ln>
        <a:solidFill>
          <a:schemeClr val="tx2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60000"/>
            <a:lumOff val="40000"/>
          </a:schemeClr>
        </a:solidFill>
        <a:prstDash val="dash"/>
      </a:ln>
    </cs:spPr>
  </cs:hiLoLine>
  <cs:leader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2"/>
    </cs:fontRef>
    <cs:defRPr sz="1197" kern="1200"/>
  </cs:legend>
  <cs:plotArea>
    <cs:lnRef idx="0"/>
    <cs:fillRef idx="0"/>
    <cs:effectRef idx="0"/>
    <cs:fontRef idx="minor">
      <a:schemeClr val="tx2"/>
    </cs:fontRef>
  </cs:plotArea>
  <cs:plotArea3D>
    <cs:lnRef idx="0"/>
    <cs:fillRef idx="0"/>
    <cs:effectRef idx="0"/>
    <cs:fontRef idx="minor">
      <a:schemeClr val="tx2"/>
    </cs:fontRef>
  </cs:plotArea3D>
  <cs:seriesAxis>
    <cs:lnRef idx="0"/>
    <cs:fillRef idx="0"/>
    <cs:effectRef idx="0"/>
    <cs:fontRef idx="minor">
      <a:schemeClr val="tx2"/>
    </cs:fontRef>
    <cs:spPr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  <cs:defRPr sz="1197" kern="1200"/>
  </cs:seriesAxis>
  <cs:series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60000"/>
            <a:lumOff val="40000"/>
          </a:schemeClr>
        </a:solidFill>
        <a:prstDash val="dash"/>
      </a:ln>
    </cs:spPr>
  </cs:seriesLine>
  <cs:title>
    <cs:lnRef idx="0"/>
    <cs:fillRef idx="0"/>
    <cs:effectRef idx="0"/>
    <cs:fontRef idx="minor">
      <a:schemeClr val="tx2"/>
    </cs:fontRef>
    <cs:defRPr sz="2128" b="1" kern="1200"/>
  </cs:title>
  <cs:trendline>
    <cs:lnRef idx="0">
      <cs:styleClr val="auto"/>
    </cs:lnRef>
    <cs:fillRef idx="0"/>
    <cs:effectRef idx="0"/>
    <cs:fontRef idx="minor">
      <a:schemeClr val="tx2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2"/>
    </cs:fontRef>
    <cs:defRPr sz="1197" kern="1200"/>
  </cs:trendlineLabel>
  <cs:upBar>
    <cs:lnRef idx="0"/>
    <cs:fillRef idx="0"/>
    <cs:effectRef idx="0"/>
    <cs:fontRef idx="minor">
      <a:schemeClr val="tx2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2"/>
    </cs:fontRef>
    <cs:defRPr sz="1197" kern="1200"/>
  </cs:valueAxis>
  <cs:wall>
    <cs:lnRef idx="0"/>
    <cs:fillRef idx="0"/>
    <cs:effectRef idx="0"/>
    <cs:fontRef idx="minor">
      <a:schemeClr val="tx2"/>
    </cs:fontRef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D0E3AAE8-F4A7-F095-EFB4-A5680272988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FD04BDE0-B987-106A-A192-D9E6BC5A1A2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  <a:endParaRPr lang="en-US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71A11FCD-CF74-075A-9A08-F84960D278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D5A568-90ED-4E80-8BA3-6F6E96AE76C8}" type="datetimeFigureOut">
              <a:rPr lang="en-US" smtClean="0"/>
              <a:t>2/22/2024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D202E1EB-F5D6-B389-CAF8-CC0A9C6C0D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6F29D852-548E-605C-220F-CC1A1BE35E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675AA5-E7D3-40CE-9CF2-FD16DF9BBC73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67782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4084BAE7-6A92-629B-E3B2-37E2F3E4F4E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1C22CAAB-893A-1243-B06E-57518460B29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D4312F32-C292-0385-0FEF-928441E886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D5A568-90ED-4E80-8BA3-6F6E96AE76C8}" type="datetimeFigureOut">
              <a:rPr lang="en-US" smtClean="0"/>
              <a:t>2/22/2024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9CECAD37-0051-A2D5-236C-84F106D1E7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5FBF6A3C-DFF4-8F46-B416-2F13E2AC06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675AA5-E7D3-40CE-9CF2-FD16DF9BBC73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0047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0C42F486-A474-26FF-09BD-464D98EE579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61D56BA2-FE2C-786E-57A7-5DC91ABC52D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F724923C-73D1-2896-46FE-691772884F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D5A568-90ED-4E80-8BA3-6F6E96AE76C8}" type="datetimeFigureOut">
              <a:rPr lang="en-US" smtClean="0"/>
              <a:t>2/22/2024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ABC63759-38A2-E022-635F-F6F033C2E8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E56EEC93-BAF6-E01D-1FA3-D9E8720165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675AA5-E7D3-40CE-9CF2-FD16DF9BBC73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28494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C901E841-3D92-9BE5-FCD5-5058D049C13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E949CD68-471F-F3F1-E877-2640EFF9095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A9E346C0-EAC6-1E39-227C-8B379CB48E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D5A568-90ED-4E80-8BA3-6F6E96AE76C8}" type="datetimeFigureOut">
              <a:rPr lang="en-US" smtClean="0"/>
              <a:t>2/22/2024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B6EBC150-6F49-4858-63AF-01AE98B3A9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D9F35C45-A445-A5E9-1C24-AAE5A88AD0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675AA5-E7D3-40CE-9CF2-FD16DF9BBC73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41208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29538C0B-5983-F15A-0CE4-7C9D1474A18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432B276B-1583-CF18-7796-BF4AE20DFE0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4B1B411E-64CC-9E43-E76C-F8D7B0E82B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D5A568-90ED-4E80-8BA3-6F6E96AE76C8}" type="datetimeFigureOut">
              <a:rPr lang="en-US" smtClean="0"/>
              <a:t>2/22/2024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CCC3C983-B7B8-8B6C-886B-FE0DBC15C6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130B1BA5-AE82-3409-1EBB-B28AF951CF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675AA5-E7D3-40CE-9CF2-FD16DF9BBC73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13170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2BC55214-534B-2F96-EA65-6333E2A544D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93AC5431-D38D-DDE1-B4FE-DD6D2EF796D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662B4996-AF0B-DFF1-6FD8-608230B5A5E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C5B2ABAC-8016-DFDD-F94E-4111DF146A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D5A568-90ED-4E80-8BA3-6F6E96AE76C8}" type="datetimeFigureOut">
              <a:rPr lang="en-US" smtClean="0"/>
              <a:t>2/22/2024</a:t>
            </a:fld>
            <a:endParaRPr lang="en-US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44C1E439-5232-4F63-16AB-017823B551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CB0F5618-159F-6C80-5DFF-4293334A0E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675AA5-E7D3-40CE-9CF2-FD16DF9BBC73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95554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B067C4C2-35F6-2741-0CF4-313D60F01E4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B2880DC5-DCCF-A248-1C34-AA1312AF378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8D8E3B67-D7ED-90FF-0549-E9E425D9641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93F0F2BA-6C27-4451-8BFA-8FC30B5D4F3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3BD72EB9-BE8B-9E18-7409-842132B8F8D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2A3454C9-7D89-C5FB-B46E-1CD45159D7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D5A568-90ED-4E80-8BA3-6F6E96AE76C8}" type="datetimeFigureOut">
              <a:rPr lang="en-US" smtClean="0"/>
              <a:t>2/22/2024</a:t>
            </a:fld>
            <a:endParaRPr lang="en-US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F6785C7C-DEE2-05BE-1177-46229A17E4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037C9F59-4CE3-F566-1757-3AAAD2AD68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675AA5-E7D3-40CE-9CF2-FD16DF9BBC73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78556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5B6AD0CA-1339-0528-CFEE-95C4D684AAB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5A39A6E3-3673-1F8B-D116-E1A572DE82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D5A568-90ED-4E80-8BA3-6F6E96AE76C8}" type="datetimeFigureOut">
              <a:rPr lang="en-US" smtClean="0"/>
              <a:t>2/22/2024</a:t>
            </a:fld>
            <a:endParaRPr lang="en-US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9228ABF5-30A5-5366-64D5-E539C36DBD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CCCD51AD-B78E-8864-0991-E5D714F6B5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675AA5-E7D3-40CE-9CF2-FD16DF9BBC73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41343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D45FF2A2-5001-A7BE-4F12-9C3A7E81B4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D5A568-90ED-4E80-8BA3-6F6E96AE76C8}" type="datetimeFigureOut">
              <a:rPr lang="en-US" smtClean="0"/>
              <a:t>2/22/2024</a:t>
            </a:fld>
            <a:endParaRPr lang="en-US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B165F032-1B42-0872-5824-6D1AE1743A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647E87C8-C11C-88F9-7DE0-FED5F485C6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675AA5-E7D3-40CE-9CF2-FD16DF9BBC73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3836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10DB0DAC-4012-591A-DE14-B5AFD876BF7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D1B7395B-E62C-E34B-1114-63BFDCBE5CE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650CDC1D-EB68-991B-3722-E2EE8F5DF3C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157A4977-FC42-BE0E-B2AE-3337EE54F2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D5A568-90ED-4E80-8BA3-6F6E96AE76C8}" type="datetimeFigureOut">
              <a:rPr lang="en-US" smtClean="0"/>
              <a:t>2/22/2024</a:t>
            </a:fld>
            <a:endParaRPr lang="en-US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234C8737-5B33-78EB-8312-D166413FE3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C08891D4-5C77-0222-9787-B2594B1960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675AA5-E7D3-40CE-9CF2-FD16DF9BBC73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09743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63F732DB-7751-0D63-D193-68F83739685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66B1B5C1-4962-D650-730B-F928BA86ACD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60956CFB-DD79-5EEC-9A77-65E0BBB5E5C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90BF1CD5-8A2B-9ABA-22C2-9A1CEF06B2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D5A568-90ED-4E80-8BA3-6F6E96AE76C8}" type="datetimeFigureOut">
              <a:rPr lang="en-US" smtClean="0"/>
              <a:t>2/22/2024</a:t>
            </a:fld>
            <a:endParaRPr lang="en-US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39784169-11BB-2CC3-CAE6-CFC582E29F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DB1B29EA-25E7-4D30-44C9-672BCE3C81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675AA5-E7D3-40CE-9CF2-FD16DF9BBC73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6212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D3B8A08F-79F8-0462-3618-831462C48FC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879F8F0E-7C5D-09C6-C782-D8CD224B353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50A1556C-D291-30A6-12E6-1D456B85DC2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D5A568-90ED-4E80-8BA3-6F6E96AE76C8}" type="datetimeFigureOut">
              <a:rPr lang="en-US" smtClean="0"/>
              <a:t>2/22/2024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7488A9B0-1C6D-5462-EF3B-A3600C5C565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CF7D18E2-01F8-C5D1-634A-FA39C1DC1CB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675AA5-E7D3-40CE-9CF2-FD16DF9BBC73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68547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uppo 5">
            <a:extLst>
              <a:ext uri="{FF2B5EF4-FFF2-40B4-BE49-F238E27FC236}">
                <a16:creationId xmlns:a16="http://schemas.microsoft.com/office/drawing/2014/main" id="{F1A5AACE-D6E1-B7F3-BB61-2355FA57EF6D}"/>
              </a:ext>
            </a:extLst>
          </p:cNvPr>
          <p:cNvGrpSpPr/>
          <p:nvPr/>
        </p:nvGrpSpPr>
        <p:grpSpPr>
          <a:xfrm>
            <a:off x="1659480" y="372836"/>
            <a:ext cx="8873041" cy="5865866"/>
            <a:chOff x="1659480" y="372836"/>
            <a:chExt cx="8873041" cy="5865866"/>
          </a:xfrm>
        </p:grpSpPr>
        <p:graphicFrame>
          <p:nvGraphicFramePr>
            <p:cNvPr id="3" name="Grafico 2">
              <a:extLst>
                <a:ext uri="{FF2B5EF4-FFF2-40B4-BE49-F238E27FC236}">
                  <a16:creationId xmlns:a16="http://schemas.microsoft.com/office/drawing/2014/main" id="{60297A58-8D37-4DD6-B198-997DBBFAB126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653323687"/>
                </p:ext>
              </p:extLst>
            </p:nvPr>
          </p:nvGraphicFramePr>
          <p:xfrm>
            <a:off x="1659480" y="372836"/>
            <a:ext cx="8873040" cy="5293179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5" name="CasellaDiTesto 4">
              <a:extLst>
                <a:ext uri="{FF2B5EF4-FFF2-40B4-BE49-F238E27FC236}">
                  <a16:creationId xmlns:a16="http://schemas.microsoft.com/office/drawing/2014/main" id="{A566483B-E3FD-04D1-AFA0-6A7ACA6AFB2F}"/>
                </a:ext>
              </a:extLst>
            </p:cNvPr>
            <p:cNvSpPr txBox="1"/>
            <p:nvPr/>
          </p:nvSpPr>
          <p:spPr>
            <a:xfrm>
              <a:off x="1659480" y="5992481"/>
              <a:ext cx="8873041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1000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Supplementary Figure </a:t>
              </a:r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. EQ-5D Health Profile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68757856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02</TotalTime>
  <Words>7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i Office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manila.boarini</dc:creator>
  <cp:lastModifiedBy>manuela locatelli</cp:lastModifiedBy>
  <cp:revision>12</cp:revision>
  <cp:lastPrinted>2023-06-01T11:44:44Z</cp:lastPrinted>
  <dcterms:created xsi:type="dcterms:W3CDTF">2023-06-01T08:20:09Z</dcterms:created>
  <dcterms:modified xsi:type="dcterms:W3CDTF">2024-02-22T08:20:11Z</dcterms:modified>
</cp:coreProperties>
</file>